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2" r:id="rId2"/>
  </p:sldIdLst>
  <p:sldSz cx="7559675" cy="9936163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583" userDrawn="1">
          <p15:clr>
            <a:srgbClr val="A4A3A4"/>
          </p15:clr>
        </p15:guide>
        <p15:guide id="3" orient="horz" pos="4286" userDrawn="1">
          <p15:clr>
            <a:srgbClr val="A4A3A4"/>
          </p15:clr>
        </p15:guide>
        <p15:guide id="4" orient="horz" pos="5692" userDrawn="1">
          <p15:clr>
            <a:srgbClr val="A4A3A4"/>
          </p15:clr>
        </p15:guide>
        <p15:guide id="5" orient="horz" pos="930" userDrawn="1">
          <p15:clr>
            <a:srgbClr val="A4A3A4"/>
          </p15:clr>
        </p15:guide>
        <p15:guide id="7" orient="horz" pos="3515" userDrawn="1">
          <p15:clr>
            <a:srgbClr val="A4A3A4"/>
          </p15:clr>
        </p15:guide>
        <p15:guide id="8" orient="horz" pos="2608" userDrawn="1">
          <p15:clr>
            <a:srgbClr val="A4A3A4"/>
          </p15:clr>
        </p15:guide>
        <p15:guide id="9" orient="horz" pos="4649" userDrawn="1">
          <p15:clr>
            <a:srgbClr val="A4A3A4"/>
          </p15:clr>
        </p15:guide>
        <p15:guide id="11" orient="horz" pos="4762" userDrawn="1">
          <p15:clr>
            <a:srgbClr val="A4A3A4"/>
          </p15:clr>
        </p15:guide>
        <p15:guide id="12" pos="467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腫瘍内科 近畿大学医学部" initials="腫近" lastIdx="1" clrIdx="0">
    <p:extLst>
      <p:ext uri="{19B8F6BF-5375-455C-9EA6-DF929625EA0E}">
        <p15:presenceInfo xmlns:p15="http://schemas.microsoft.com/office/powerpoint/2012/main" userId="b406ef13a87962d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82B4C"/>
    <a:srgbClr val="CCECFF"/>
    <a:srgbClr val="61FF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スタイル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スタイル (濃色)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27"/>
  </p:normalViewPr>
  <p:slideViewPr>
    <p:cSldViewPr snapToGrid="0" snapToObjects="1" showGuides="1">
      <p:cViewPr>
        <p:scale>
          <a:sx n="110" d="100"/>
          <a:sy n="110" d="100"/>
        </p:scale>
        <p:origin x="2226" y="-882"/>
      </p:cViewPr>
      <p:guideLst>
        <p:guide pos="3583"/>
        <p:guide orient="horz" pos="4286"/>
        <p:guide orient="horz" pos="5692"/>
        <p:guide orient="horz" pos="930"/>
        <p:guide orient="horz" pos="3515"/>
        <p:guide orient="horz" pos="2608"/>
        <p:guide orient="horz" pos="4649"/>
        <p:guide orient="horz" pos="4762"/>
        <p:guide pos="467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342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r">
              <a:defRPr sz="1200"/>
            </a:lvl1pPr>
          </a:lstStyle>
          <a:p>
            <a:fld id="{6F465158-8CF6-4271-801C-4DF7DC969FD4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7250" y="1243013"/>
            <a:ext cx="254793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4" tIns="45688" rIns="91374" bIns="4568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0846"/>
            <a:ext cx="5441316" cy="3911312"/>
          </a:xfrm>
          <a:prstGeom prst="rect">
            <a:avLst/>
          </a:prstGeom>
        </p:spPr>
        <p:txBody>
          <a:bodyPr vert="horz" lIns="91374" tIns="45688" rIns="91374" bIns="4568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342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r">
              <a:defRPr sz="1200"/>
            </a:lvl1pPr>
          </a:lstStyle>
          <a:p>
            <a:fld id="{2D556CFF-E290-41EC-82C8-7E6D0EEA4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46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26127"/>
            <a:ext cx="6425724" cy="345925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18786"/>
            <a:ext cx="5669756" cy="239893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573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57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29009"/>
            <a:ext cx="1630055" cy="842043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29009"/>
            <a:ext cx="4795669" cy="842043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80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379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77144"/>
            <a:ext cx="6520220" cy="4133167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649412"/>
            <a:ext cx="6520220" cy="2173535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418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12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29011"/>
            <a:ext cx="6520220" cy="192053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35741"/>
            <a:ext cx="3198096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29460"/>
            <a:ext cx="3198096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35741"/>
            <a:ext cx="3213847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29460"/>
            <a:ext cx="3213847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8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1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37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30626"/>
            <a:ext cx="3827085" cy="7061116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418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30626"/>
            <a:ext cx="3827085" cy="7061116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77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29011"/>
            <a:ext cx="6520220" cy="1920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45043"/>
            <a:ext cx="6520220" cy="63044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674DC-7F97-EF47-BEF5-67740BCEC122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209353"/>
            <a:ext cx="2551390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605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18A386B-6EB4-33BF-42E7-4CA35ACE1651}"/>
              </a:ext>
            </a:extLst>
          </p:cNvPr>
          <p:cNvSpPr txBox="1"/>
          <p:nvPr/>
        </p:nvSpPr>
        <p:spPr>
          <a:xfrm>
            <a:off x="145268" y="118393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8.</a:t>
            </a:r>
            <a:endParaRPr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955FED8-B46F-7BE8-09B5-6D275B157A46}"/>
              </a:ext>
            </a:extLst>
          </p:cNvPr>
          <p:cNvSpPr txBox="1"/>
          <p:nvPr/>
        </p:nvSpPr>
        <p:spPr>
          <a:xfrm>
            <a:off x="414466" y="6320638"/>
            <a:ext cx="6749921" cy="12765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. CIN inversely correlated with STING (TMEM173) expression in EGFR-mutated non-small cell lung cancer with acquired resistance to EGFR-TKIs.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 heatmap sorted by CIN z-score of gene signatures for STING activation or STING (TMEM173) mRNA expression. CIN, chromosomal instability; EGFR, epidermal growth factor receptor; STING, stimulator of interferon response </a:t>
            </a:r>
            <a:r>
              <a:rPr lang="en-US" altLang="ja-JP" sz="10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AMP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teractor 1; r, Pearson correlation coefficient.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1F4CD51-EDF0-2F62-1260-6A867BD432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633" y="3478212"/>
            <a:ext cx="7315200" cy="1323975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81456097-0449-2180-587B-05A8851769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26565" y="5121001"/>
            <a:ext cx="814718" cy="5653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9749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56</TotalTime>
  <Words>75</Words>
  <Application>Microsoft Office PowerPoint</Application>
  <PresentationFormat>ユーザー設定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慎一郎</dc:creator>
  <cp:lastModifiedBy>仁雄 米阪</cp:lastModifiedBy>
  <cp:revision>632</cp:revision>
  <cp:lastPrinted>2024-06-06T11:43:21Z</cp:lastPrinted>
  <dcterms:created xsi:type="dcterms:W3CDTF">2021-02-12T07:53:00Z</dcterms:created>
  <dcterms:modified xsi:type="dcterms:W3CDTF">2025-03-05T01:19:05Z</dcterms:modified>
</cp:coreProperties>
</file>